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4684" autoAdjust="0"/>
  </p:normalViewPr>
  <p:slideViewPr>
    <p:cSldViewPr>
      <p:cViewPr varScale="1">
        <p:scale>
          <a:sx n="75" d="100"/>
          <a:sy n="75" d="100"/>
        </p:scale>
        <p:origin x="-840" y="-9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57"/>
          <p:cNvGrpSpPr/>
          <p:nvPr/>
        </p:nvGrpSpPr>
        <p:grpSpPr>
          <a:xfrm>
            <a:off x="381000" y="228600"/>
            <a:ext cx="9321526" cy="6607940"/>
            <a:chOff x="381000" y="228600"/>
            <a:chExt cx="9321526" cy="6607940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 rot="5400000">
              <a:off x="2068130" y="-467930"/>
              <a:ext cx="6074540" cy="853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381000" y="228600"/>
              <a:ext cx="932152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Fig. S1A. The optimal structure of the RTSV leader predicted by the Wisconsin GCG MFOLD</a:t>
              </a:r>
            </a:p>
            <a:p>
              <a:r>
                <a:rPr lang="en-US" dirty="0" smtClean="0"/>
                <a:t>         (with positions of the </a:t>
              </a:r>
              <a:r>
                <a:rPr lang="en-US" dirty="0" err="1" smtClean="0"/>
                <a:t>sORFs</a:t>
              </a:r>
              <a:r>
                <a:rPr lang="en-US" dirty="0" smtClean="0"/>
                <a:t>’ start and stop </a:t>
              </a:r>
              <a:r>
                <a:rPr lang="en-US" dirty="0" err="1" smtClean="0"/>
                <a:t>codons</a:t>
              </a:r>
              <a:r>
                <a:rPr lang="en-US" dirty="0" smtClean="0"/>
                <a:t> indicated in red and green, respectively) </a:t>
              </a:r>
              <a:endParaRPr lang="en-US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576763" y="4743452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A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719637" y="4710095"/>
              <a:ext cx="25840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U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838704" y="4772353"/>
              <a:ext cx="25680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G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829178" y="4433889"/>
              <a:ext cx="25840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00B050"/>
                  </a:solidFill>
                </a:rPr>
                <a:t>U</a:t>
              </a:r>
              <a:endParaRPr lang="en-US" sz="900" dirty="0">
                <a:solidFill>
                  <a:srgbClr val="00B050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957763" y="4395785"/>
              <a:ext cx="25680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00B050"/>
                  </a:solidFill>
                </a:rPr>
                <a:t>G</a:t>
              </a:r>
              <a:endParaRPr lang="en-US" sz="900" dirty="0">
                <a:solidFill>
                  <a:srgbClr val="00B050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081861" y="4452941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00B050"/>
                  </a:solidFill>
                </a:rPr>
                <a:t>A</a:t>
              </a:r>
              <a:endParaRPr lang="en-US" sz="900" dirty="0">
                <a:solidFill>
                  <a:srgbClr val="00B050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91000" y="4514860"/>
              <a:ext cx="58381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i="1" dirty="0" smtClean="0">
                  <a:solidFill>
                    <a:srgbClr val="FF0000"/>
                  </a:solidFill>
                </a:rPr>
                <a:t>sORF1</a:t>
              </a:r>
              <a:endParaRPr lang="en-US" sz="1200" b="1" i="1" dirty="0">
                <a:solidFill>
                  <a:srgbClr val="FF0000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805489" y="4048126"/>
              <a:ext cx="235962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FF0000"/>
                  </a:solidFill>
                </a:rPr>
                <a:t>A</a:t>
              </a:r>
              <a:endParaRPr lang="en-US" sz="700" dirty="0">
                <a:solidFill>
                  <a:srgbClr val="FF0000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853108" y="3990945"/>
              <a:ext cx="242374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FF0000"/>
                  </a:solidFill>
                </a:rPr>
                <a:t>U</a:t>
              </a:r>
              <a:endParaRPr lang="en-US" sz="700" dirty="0">
                <a:solidFill>
                  <a:srgbClr val="FF0000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905496" y="3919549"/>
              <a:ext cx="240772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FF0000"/>
                  </a:solidFill>
                </a:rPr>
                <a:t>G</a:t>
              </a:r>
              <a:endParaRPr lang="en-US" sz="700" dirty="0">
                <a:solidFill>
                  <a:srgbClr val="FF0000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529259" y="3829060"/>
              <a:ext cx="47801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solidFill>
                    <a:srgbClr val="00B050"/>
                  </a:solidFill>
                </a:rPr>
                <a:t>sORF2</a:t>
              </a:r>
              <a:endParaRPr lang="en-US" sz="900" i="1" dirty="0">
                <a:solidFill>
                  <a:srgbClr val="00B050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948352" y="3862344"/>
              <a:ext cx="242374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00B050"/>
                  </a:solidFill>
                </a:rPr>
                <a:t>U</a:t>
              </a:r>
              <a:endParaRPr lang="en-US" sz="700" dirty="0">
                <a:solidFill>
                  <a:srgbClr val="00B050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000740" y="3810000"/>
              <a:ext cx="240772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00B050"/>
                  </a:solidFill>
                </a:rPr>
                <a:t>G</a:t>
              </a:r>
              <a:endParaRPr lang="en-US" sz="700" dirty="0">
                <a:solidFill>
                  <a:srgbClr val="00B050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953115" y="3781357"/>
              <a:ext cx="235962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00B050"/>
                  </a:solidFill>
                </a:rPr>
                <a:t>A</a:t>
              </a:r>
              <a:endParaRPr lang="en-US" sz="700" dirty="0">
                <a:solidFill>
                  <a:srgbClr val="00B050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429252" y="2598094"/>
              <a:ext cx="2439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A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361344" y="2547941"/>
              <a:ext cx="25039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U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624385" y="2283768"/>
              <a:ext cx="2487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G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676778" y="2214563"/>
              <a:ext cx="25039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U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372464" y="2452689"/>
              <a:ext cx="2487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G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757741" y="2212323"/>
              <a:ext cx="2439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A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029200" y="2667000"/>
              <a:ext cx="47801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solidFill>
                    <a:srgbClr val="00B050"/>
                  </a:solidFill>
                </a:rPr>
                <a:t>sORF3</a:t>
              </a:r>
              <a:endParaRPr lang="en-US" sz="900" i="1" dirty="0">
                <a:solidFill>
                  <a:srgbClr val="00B050"/>
                </a:solidFill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557679" y="2298041"/>
              <a:ext cx="2439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50"/>
                  </a:solidFill>
                </a:rPr>
                <a:t>A</a:t>
              </a:r>
              <a:endParaRPr lang="en-US" sz="800" dirty="0">
                <a:solidFill>
                  <a:srgbClr val="00B050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533896" y="2452689"/>
              <a:ext cx="47801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solidFill>
                    <a:srgbClr val="00B050"/>
                  </a:solidFill>
                </a:rPr>
                <a:t>sORF4</a:t>
              </a:r>
              <a:endParaRPr lang="en-US" sz="900" i="1" dirty="0">
                <a:solidFill>
                  <a:srgbClr val="00B050"/>
                </a:solidFill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819400" y="3350568"/>
              <a:ext cx="47801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solidFill>
                    <a:srgbClr val="00B050"/>
                  </a:solidFill>
                </a:rPr>
                <a:t>sORF5</a:t>
              </a:r>
              <a:endParaRPr lang="en-US" sz="900" i="1" dirty="0">
                <a:solidFill>
                  <a:srgbClr val="00B050"/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728919" y="2960058"/>
              <a:ext cx="2487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50"/>
                  </a:solidFill>
                </a:rPr>
                <a:t>G</a:t>
              </a:r>
              <a:endParaRPr lang="en-US" sz="800" dirty="0">
                <a:solidFill>
                  <a:srgbClr val="00B050"/>
                </a:solidFill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728911" y="2881327"/>
              <a:ext cx="2439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50"/>
                  </a:solidFill>
                </a:rPr>
                <a:t>A</a:t>
              </a:r>
              <a:endParaRPr lang="en-US" sz="800" dirty="0">
                <a:solidFill>
                  <a:srgbClr val="00B050"/>
                </a:solidFill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714614" y="2802879"/>
              <a:ext cx="25039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50"/>
                  </a:solidFill>
                </a:rPr>
                <a:t>U</a:t>
              </a:r>
              <a:endParaRPr lang="en-US" sz="800" dirty="0">
                <a:solidFill>
                  <a:srgbClr val="00B050"/>
                </a:solidFill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828926" y="3052763"/>
              <a:ext cx="25039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U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757473" y="3052779"/>
              <a:ext cx="2439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A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871785" y="3121968"/>
              <a:ext cx="2487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G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981200" y="2590800"/>
              <a:ext cx="50687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solidFill>
                    <a:srgbClr val="00B050"/>
                  </a:solidFill>
                </a:rPr>
                <a:t>sORF5’</a:t>
              </a:r>
              <a:endParaRPr lang="en-US" sz="900" i="1" dirty="0">
                <a:solidFill>
                  <a:srgbClr val="00B050"/>
                </a:solidFill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409830" y="2336153"/>
              <a:ext cx="2487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50"/>
                  </a:solidFill>
                </a:rPr>
                <a:t>G</a:t>
              </a:r>
              <a:endParaRPr lang="en-US" sz="800" dirty="0">
                <a:solidFill>
                  <a:srgbClr val="00B050"/>
                </a:solidFill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348334" y="2309815"/>
              <a:ext cx="2439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50"/>
                  </a:solidFill>
                </a:rPr>
                <a:t>A</a:t>
              </a:r>
              <a:endParaRPr lang="en-US" sz="800" dirty="0">
                <a:solidFill>
                  <a:srgbClr val="00B050"/>
                </a:solidFill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428874" y="2357437"/>
              <a:ext cx="25039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50"/>
                  </a:solidFill>
                </a:rPr>
                <a:t>U</a:t>
              </a:r>
              <a:endParaRPr lang="en-US" sz="800" dirty="0">
                <a:solidFill>
                  <a:srgbClr val="00B050"/>
                </a:solidFill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362200" y="2459975"/>
              <a:ext cx="25039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U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400296" y="2524126"/>
              <a:ext cx="2439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A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438400" y="2419356"/>
              <a:ext cx="2487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G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084584" y="1447800"/>
              <a:ext cx="47801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solidFill>
                    <a:srgbClr val="00B050"/>
                  </a:solidFill>
                </a:rPr>
                <a:t>sORF6</a:t>
              </a:r>
              <a:endParaRPr lang="en-US" sz="900" i="1" dirty="0">
                <a:solidFill>
                  <a:srgbClr val="00B050"/>
                </a:solidFill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034089" y="2819400"/>
              <a:ext cx="2487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50"/>
                  </a:solidFill>
                </a:rPr>
                <a:t>G</a:t>
              </a:r>
              <a:endParaRPr lang="en-US" sz="800" dirty="0">
                <a:solidFill>
                  <a:srgbClr val="00B050"/>
                </a:solidFill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6096000" y="2871785"/>
              <a:ext cx="2439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50"/>
                  </a:solidFill>
                </a:rPr>
                <a:t>A</a:t>
              </a:r>
              <a:endParaRPr lang="en-US" sz="800" dirty="0">
                <a:solidFill>
                  <a:srgbClr val="00B050"/>
                </a:solidFill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6096000" y="2795593"/>
              <a:ext cx="25039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50"/>
                  </a:solidFill>
                </a:rPr>
                <a:t>U</a:t>
              </a:r>
              <a:endParaRPr lang="en-US" sz="800" dirty="0">
                <a:solidFill>
                  <a:srgbClr val="00B050"/>
                </a:solidFill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304196" y="1717027"/>
              <a:ext cx="25039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U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276852" y="1766889"/>
              <a:ext cx="24397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0000"/>
                  </a:solidFill>
                </a:rPr>
                <a:t>A</a:t>
              </a:r>
              <a:endParaRPr 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248274" y="1657356"/>
              <a:ext cx="25680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G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55" name="Oval 54"/>
            <p:cNvSpPr/>
            <p:nvPr/>
          </p:nvSpPr>
          <p:spPr>
            <a:xfrm rot="2291047">
              <a:off x="5452282" y="3284996"/>
              <a:ext cx="1135458" cy="1807377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495800" y="3761601"/>
              <a:ext cx="9765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solidFill>
                    <a:srgbClr val="FF0000"/>
                  </a:solidFill>
                </a:rPr>
                <a:t>Basal helix</a:t>
              </a:r>
              <a:endParaRPr lang="en-US" sz="1400" b="1" dirty="0">
                <a:solidFill>
                  <a:srgbClr val="FF0000"/>
                </a:solidFill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092609" y="5029200"/>
              <a:ext cx="110498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FF0000"/>
                  </a:solidFill>
                </a:rPr>
                <a:t>Shunt landing </a:t>
              </a:r>
            </a:p>
            <a:p>
              <a:pPr algn="ctr"/>
              <a:r>
                <a:rPr lang="en-US" sz="1200" b="1" dirty="0" smtClean="0">
                  <a:solidFill>
                    <a:srgbClr val="FF0000"/>
                  </a:solidFill>
                </a:rPr>
                <a:t>site</a:t>
              </a:r>
              <a:endParaRPr lang="en-US" sz="1200" b="1" dirty="0">
                <a:solidFill>
                  <a:srgbClr val="FF0000"/>
                </a:solidFill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304800" y="164068"/>
            <a:ext cx="9220199" cy="6700176"/>
            <a:chOff x="304800" y="164068"/>
            <a:chExt cx="9220199" cy="6700176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 rot="5400000">
              <a:off x="1013565" y="-22966"/>
              <a:ext cx="3124201" cy="4389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 rot="5400000">
              <a:off x="5675378" y="-39621"/>
              <a:ext cx="3048001" cy="4346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304800" y="164068"/>
              <a:ext cx="88355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Fig. S1B. The optimal and suboptimal structures of the RTSV leader predicted by the MFOLD </a:t>
              </a:r>
              <a:endParaRPr lang="en-US" dirty="0"/>
            </a:p>
          </p:txBody>
        </p:sp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 rot="5400000">
              <a:off x="1061140" y="3048584"/>
              <a:ext cx="3135520" cy="4495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 rot="5400000">
              <a:off x="5788401" y="3121401"/>
              <a:ext cx="3093194" cy="43800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" name="Oval 7"/>
            <p:cNvSpPr/>
            <p:nvPr/>
          </p:nvSpPr>
          <p:spPr>
            <a:xfrm rot="2291047">
              <a:off x="2760158" y="1871332"/>
              <a:ext cx="530957" cy="1082752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905000" y="2057400"/>
              <a:ext cx="7841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solidFill>
                    <a:srgbClr val="FF0000"/>
                  </a:solidFill>
                </a:rPr>
                <a:t>Basal helix</a:t>
              </a:r>
              <a:endParaRPr lang="en-US" sz="1050" dirty="0">
                <a:solidFill>
                  <a:srgbClr val="FF0000"/>
                </a:solidFill>
              </a:endParaRPr>
            </a:p>
          </p:txBody>
        </p:sp>
        <p:sp>
          <p:nvSpPr>
            <p:cNvPr id="10" name="Oval 9"/>
            <p:cNvSpPr/>
            <p:nvPr/>
          </p:nvSpPr>
          <p:spPr>
            <a:xfrm rot="2291047">
              <a:off x="7457858" y="1807968"/>
              <a:ext cx="502887" cy="1043872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683411" y="1981200"/>
              <a:ext cx="7841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solidFill>
                    <a:srgbClr val="FF0000"/>
                  </a:solidFill>
                </a:rPr>
                <a:t>Basal helix</a:t>
              </a:r>
              <a:endParaRPr lang="en-US" sz="1050" dirty="0">
                <a:solidFill>
                  <a:srgbClr val="FF0000"/>
                </a:solidFill>
              </a:endParaRPr>
            </a:p>
          </p:txBody>
        </p:sp>
        <p:sp>
          <p:nvSpPr>
            <p:cNvPr id="12" name="Oval 11"/>
            <p:cNvSpPr/>
            <p:nvPr/>
          </p:nvSpPr>
          <p:spPr>
            <a:xfrm rot="1717337">
              <a:off x="7923082" y="4884039"/>
              <a:ext cx="502887" cy="1043872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064411" y="5105399"/>
              <a:ext cx="7841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solidFill>
                    <a:srgbClr val="FF0000"/>
                  </a:solidFill>
                </a:rPr>
                <a:t>Basal helix</a:t>
              </a:r>
              <a:endParaRPr lang="en-US" sz="1050" dirty="0">
                <a:solidFill>
                  <a:srgbClr val="FF0000"/>
                </a:solidFill>
              </a:endParaRPr>
            </a:p>
          </p:txBody>
        </p:sp>
        <p:sp>
          <p:nvSpPr>
            <p:cNvPr id="14" name="Oval 13"/>
            <p:cNvSpPr/>
            <p:nvPr/>
          </p:nvSpPr>
          <p:spPr>
            <a:xfrm rot="2563150">
              <a:off x="2458262" y="4844863"/>
              <a:ext cx="502887" cy="1131148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806611" y="5093793"/>
              <a:ext cx="7841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solidFill>
                    <a:srgbClr val="FF0000"/>
                  </a:solidFill>
                </a:rPr>
                <a:t>Basal helix</a:t>
              </a:r>
              <a:endParaRPr lang="en-US" sz="1050" dirty="0">
                <a:solidFill>
                  <a:srgbClr val="FF0000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905000" y="2514600"/>
              <a:ext cx="51809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i="1" dirty="0" smtClean="0">
                  <a:solidFill>
                    <a:srgbClr val="FF0000"/>
                  </a:solidFill>
                </a:rPr>
                <a:t>sORF1</a:t>
              </a:r>
              <a:endParaRPr lang="en-US" sz="1000" i="1" dirty="0">
                <a:solidFill>
                  <a:srgbClr val="FF0000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644709" y="2514600"/>
              <a:ext cx="51809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i="1" dirty="0" smtClean="0">
                  <a:solidFill>
                    <a:srgbClr val="FF0000"/>
                  </a:solidFill>
                </a:rPr>
                <a:t>sORF1</a:t>
              </a:r>
              <a:endParaRPr lang="en-US" sz="1000" i="1" dirty="0">
                <a:solidFill>
                  <a:srgbClr val="FF0000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524000" y="5621179"/>
              <a:ext cx="51809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i="1" dirty="0" smtClean="0">
                  <a:solidFill>
                    <a:srgbClr val="FF0000"/>
                  </a:solidFill>
                </a:rPr>
                <a:t>sORF1</a:t>
              </a:r>
              <a:endParaRPr lang="en-US" sz="1000" i="1" dirty="0">
                <a:solidFill>
                  <a:srgbClr val="FF0000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254309" y="5638800"/>
              <a:ext cx="51809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i="1" dirty="0" smtClean="0">
                  <a:solidFill>
                    <a:srgbClr val="FF0000"/>
                  </a:solidFill>
                </a:rPr>
                <a:t>sORF1</a:t>
              </a:r>
              <a:endParaRPr lang="en-US" sz="1000" i="1" dirty="0">
                <a:solidFill>
                  <a:srgbClr val="FF0000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971800" y="2779296"/>
              <a:ext cx="8755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hunt landing </a:t>
              </a:r>
            </a:p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ite</a:t>
              </a:r>
              <a:endParaRPr lang="en-US" sz="900" b="1" dirty="0">
                <a:solidFill>
                  <a:srgbClr val="FF0000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595936" y="2747208"/>
              <a:ext cx="8755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hunt landing </a:t>
              </a:r>
            </a:p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ite</a:t>
              </a:r>
              <a:endParaRPr lang="en-US" sz="900" b="1" dirty="0">
                <a:solidFill>
                  <a:srgbClr val="FF0000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8091976" y="5915164"/>
              <a:ext cx="8755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hunt landing </a:t>
              </a:r>
            </a:p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ite</a:t>
              </a:r>
              <a:endParaRPr lang="en-US" sz="900" b="1" dirty="0">
                <a:solidFill>
                  <a:srgbClr val="FF0000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671008" y="5887084"/>
              <a:ext cx="8755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hunt landing </a:t>
              </a:r>
            </a:p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ite</a:t>
              </a:r>
              <a:endParaRPr lang="en-US" sz="900" b="1" dirty="0">
                <a:solidFill>
                  <a:srgbClr val="FF0000"/>
                </a:solidFill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304800" y="164068"/>
            <a:ext cx="9296400" cy="6693932"/>
            <a:chOff x="304800" y="164068"/>
            <a:chExt cx="9296400" cy="6693932"/>
          </a:xfrm>
        </p:grpSpPr>
        <p:grpSp>
          <p:nvGrpSpPr>
            <p:cNvPr id="7" name="Group 6"/>
            <p:cNvGrpSpPr/>
            <p:nvPr/>
          </p:nvGrpSpPr>
          <p:grpSpPr>
            <a:xfrm>
              <a:off x="304800" y="164068"/>
              <a:ext cx="9296400" cy="6693932"/>
              <a:chOff x="304800" y="164068"/>
              <a:chExt cx="9296400" cy="6693932"/>
            </a:xfrm>
          </p:grpSpPr>
          <p:pic>
            <p:nvPicPr>
              <p:cNvPr id="4" name="Picture 6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 rot="5400000">
                <a:off x="973031" y="48566"/>
                <a:ext cx="3169402" cy="45058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5" name="Picture 7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 rot="5400000">
                <a:off x="5745797" y="99556"/>
                <a:ext cx="3146246" cy="44270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304800" y="164068"/>
                <a:ext cx="912326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S1B. The optimal and suboptimal structures of the RTSV leader predicted by the MFOLD (cont.) </a:t>
                </a:r>
                <a:endParaRPr lang="en-US" dirty="0"/>
              </a:p>
            </p:txBody>
          </p:sp>
          <p:pic>
            <p:nvPicPr>
              <p:cNvPr id="9" name="Picture 8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 rot="5400000">
                <a:off x="1023940" y="3081340"/>
                <a:ext cx="3133720" cy="4419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" name="Picture 9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 rot="5400000">
                <a:off x="5889853" y="3146653"/>
                <a:ext cx="3079293" cy="434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11" name="Oval 10"/>
            <p:cNvSpPr/>
            <p:nvPr/>
          </p:nvSpPr>
          <p:spPr>
            <a:xfrm rot="2291047">
              <a:off x="7701188" y="2117865"/>
              <a:ext cx="502887" cy="996217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912011" y="2285999"/>
              <a:ext cx="7841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solidFill>
                    <a:srgbClr val="FF0000"/>
                  </a:solidFill>
                </a:rPr>
                <a:t>Basal helix</a:t>
              </a:r>
              <a:endParaRPr lang="en-US" sz="1050" dirty="0">
                <a:solidFill>
                  <a:srgbClr val="FF0000"/>
                </a:solidFill>
              </a:endParaRPr>
            </a:p>
          </p:txBody>
        </p:sp>
        <p:sp>
          <p:nvSpPr>
            <p:cNvPr id="13" name="Oval 12"/>
            <p:cNvSpPr/>
            <p:nvPr/>
          </p:nvSpPr>
          <p:spPr>
            <a:xfrm rot="3095251">
              <a:off x="2531663" y="2298392"/>
              <a:ext cx="502887" cy="970673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676400" y="2514599"/>
              <a:ext cx="7841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solidFill>
                    <a:srgbClr val="FF0000"/>
                  </a:solidFill>
                </a:rPr>
                <a:t>Basal helix</a:t>
              </a:r>
              <a:endParaRPr lang="en-US" sz="1050" dirty="0">
                <a:solidFill>
                  <a:srgbClr val="FF0000"/>
                </a:solidFill>
              </a:endParaRPr>
            </a:p>
          </p:txBody>
        </p:sp>
        <p:sp>
          <p:nvSpPr>
            <p:cNvPr id="15" name="Oval 14"/>
            <p:cNvSpPr/>
            <p:nvPr/>
          </p:nvSpPr>
          <p:spPr>
            <a:xfrm rot="2554762">
              <a:off x="7229776" y="4923722"/>
              <a:ext cx="502887" cy="1107930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416840" y="5377190"/>
              <a:ext cx="7841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solidFill>
                    <a:srgbClr val="FF0000"/>
                  </a:solidFill>
                </a:rPr>
                <a:t>Basal helix</a:t>
              </a:r>
              <a:endParaRPr lang="en-US" sz="1050" dirty="0">
                <a:solidFill>
                  <a:srgbClr val="FF0000"/>
                </a:solidFill>
              </a:endParaRPr>
            </a:p>
          </p:txBody>
        </p:sp>
        <p:sp>
          <p:nvSpPr>
            <p:cNvPr id="17" name="Oval 16"/>
            <p:cNvSpPr/>
            <p:nvPr/>
          </p:nvSpPr>
          <p:spPr>
            <a:xfrm rot="2025945">
              <a:off x="2336128" y="5031323"/>
              <a:ext cx="404430" cy="958489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654211" y="5224790"/>
              <a:ext cx="7841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solidFill>
                    <a:srgbClr val="FF0000"/>
                  </a:solidFill>
                </a:rPr>
                <a:t>Basal helix</a:t>
              </a:r>
              <a:endParaRPr lang="en-US" sz="1050" dirty="0">
                <a:solidFill>
                  <a:srgbClr val="FF0000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676400" y="2877979"/>
              <a:ext cx="51809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i="1" dirty="0" smtClean="0">
                  <a:solidFill>
                    <a:srgbClr val="FF0000"/>
                  </a:solidFill>
                </a:rPr>
                <a:t>sORF1</a:t>
              </a:r>
              <a:endParaRPr lang="en-US" sz="1000" i="1" dirty="0">
                <a:solidFill>
                  <a:srgbClr val="FF0000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985605" y="2777715"/>
              <a:ext cx="51809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i="1" dirty="0" smtClean="0">
                  <a:solidFill>
                    <a:srgbClr val="FF0000"/>
                  </a:solidFill>
                </a:rPr>
                <a:t>sORF1</a:t>
              </a:r>
              <a:endParaRPr lang="en-US" sz="1000" i="1" dirty="0">
                <a:solidFill>
                  <a:srgbClr val="FF0000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612224" y="5697379"/>
              <a:ext cx="51809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i="1" dirty="0" smtClean="0">
                  <a:solidFill>
                    <a:srgbClr val="FF0000"/>
                  </a:solidFill>
                </a:rPr>
                <a:t>sORF1</a:t>
              </a:r>
              <a:endParaRPr lang="en-US" sz="1000" i="1" dirty="0">
                <a:solidFill>
                  <a:srgbClr val="FF0000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339909" y="5697379"/>
              <a:ext cx="51809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i="1" dirty="0" smtClean="0">
                  <a:solidFill>
                    <a:srgbClr val="FF0000"/>
                  </a:solidFill>
                </a:rPr>
                <a:t>sORF1</a:t>
              </a:r>
              <a:endParaRPr lang="en-US" sz="1000" i="1" dirty="0">
                <a:solidFill>
                  <a:srgbClr val="FF0000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800480" y="2987848"/>
              <a:ext cx="8755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hunt landing </a:t>
              </a:r>
            </a:p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ite</a:t>
              </a:r>
              <a:endParaRPr lang="en-US" sz="900" b="1" dirty="0">
                <a:solidFill>
                  <a:srgbClr val="FF0000"/>
                </a:solidFill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743200" y="3075708"/>
              <a:ext cx="8755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hunt landing </a:t>
              </a:r>
            </a:p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ite</a:t>
              </a:r>
              <a:endParaRPr lang="en-US" sz="900" b="1" dirty="0">
                <a:solidFill>
                  <a:srgbClr val="FF0000"/>
                </a:solidFill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467600" y="5955268"/>
              <a:ext cx="8755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hunt landing </a:t>
              </a:r>
            </a:p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ite</a:t>
              </a:r>
              <a:endParaRPr lang="en-US" sz="900" b="1" dirty="0">
                <a:solidFill>
                  <a:srgbClr val="FF0000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438400" y="5911148"/>
              <a:ext cx="8755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hunt landing </a:t>
              </a:r>
            </a:p>
            <a:p>
              <a:pPr algn="ctr"/>
              <a:r>
                <a:rPr lang="en-US" sz="900" b="1" dirty="0" smtClean="0">
                  <a:solidFill>
                    <a:srgbClr val="FF0000"/>
                  </a:solidFill>
                </a:rPr>
                <a:t>site</a:t>
              </a:r>
              <a:endParaRPr lang="en-US" sz="900" b="1" dirty="0">
                <a:solidFill>
                  <a:srgbClr val="FF0000"/>
                </a:solidFill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304800" y="164068"/>
            <a:ext cx="9220200" cy="6520714"/>
            <a:chOff x="304800" y="164068"/>
            <a:chExt cx="9220200" cy="6520714"/>
          </a:xfrm>
        </p:grpSpPr>
        <p:grpSp>
          <p:nvGrpSpPr>
            <p:cNvPr id="16" name="Group 15"/>
            <p:cNvGrpSpPr/>
            <p:nvPr/>
          </p:nvGrpSpPr>
          <p:grpSpPr>
            <a:xfrm>
              <a:off x="304800" y="164068"/>
              <a:ext cx="9220200" cy="6520714"/>
              <a:chOff x="304800" y="164068"/>
              <a:chExt cx="9220200" cy="6520714"/>
            </a:xfrm>
          </p:grpSpPr>
          <p:pic>
            <p:nvPicPr>
              <p:cNvPr id="4" name="Picture 10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 rot="5400000">
                <a:off x="1175715" y="-32717"/>
                <a:ext cx="3047999" cy="43326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5" name="Picture 11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 rot="5400000">
                <a:off x="5825470" y="-41930"/>
                <a:ext cx="3055659" cy="434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304800" y="164068"/>
                <a:ext cx="912326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S1B. The optimal and suboptimal structures of the RTSV leader predicted by the MFOLD (cont.) </a:t>
                </a:r>
                <a:endParaRPr lang="en-US" dirty="0"/>
              </a:p>
            </p:txBody>
          </p:sp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 rot="21347066">
                <a:off x="545650" y="4495958"/>
                <a:ext cx="4495800" cy="19053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1" name="Group 10"/>
              <p:cNvGrpSpPr/>
              <p:nvPr/>
            </p:nvGrpSpPr>
            <p:grpSpPr>
              <a:xfrm rot="21382841">
                <a:off x="5859294" y="4093528"/>
                <a:ext cx="3663770" cy="2591254"/>
                <a:chOff x="609599" y="4062664"/>
                <a:chExt cx="3823266" cy="2456660"/>
              </a:xfrm>
            </p:grpSpPr>
            <p:pic>
              <p:nvPicPr>
                <p:cNvPr id="8" name="Picture 2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 l="7317" t="39239" r="41463"/>
                <a:stretch>
                  <a:fillRect/>
                </a:stretch>
              </p:blipFill>
              <p:spPr bwMode="auto">
                <a:xfrm rot="5179787">
                  <a:off x="1295400" y="3733800"/>
                  <a:ext cx="2057398" cy="3428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9" name="Rectangle 8"/>
                <p:cNvSpPr/>
                <p:nvPr/>
              </p:nvSpPr>
              <p:spPr>
                <a:xfrm rot="21300402">
                  <a:off x="2209800" y="4062664"/>
                  <a:ext cx="2057400" cy="381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" name="Rectangle 9"/>
                <p:cNvSpPr/>
                <p:nvPr/>
              </p:nvSpPr>
              <p:spPr>
                <a:xfrm rot="21300402">
                  <a:off x="3443704" y="6138324"/>
                  <a:ext cx="989161" cy="381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2" name="TextBox 11"/>
              <p:cNvSpPr txBox="1"/>
              <p:nvPr/>
            </p:nvSpPr>
            <p:spPr>
              <a:xfrm>
                <a:off x="304800" y="3669268"/>
                <a:ext cx="9011057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S1C. The optimal structure of the RTSV leader with (on the left) and without (on the right) the </a:t>
                </a:r>
              </a:p>
              <a:p>
                <a:r>
                  <a:rPr lang="en-US" dirty="0" err="1" smtClean="0"/>
                  <a:t>Kozak</a:t>
                </a:r>
                <a:r>
                  <a:rPr lang="en-US" dirty="0" smtClean="0"/>
                  <a:t>-stem (KS) sequence insertion  </a:t>
                </a:r>
                <a:endParaRPr lang="en-US" dirty="0"/>
              </a:p>
            </p:txBody>
          </p:sp>
          <p:sp>
            <p:nvSpPr>
              <p:cNvPr id="13" name="Oval 12"/>
              <p:cNvSpPr/>
              <p:nvPr/>
            </p:nvSpPr>
            <p:spPr>
              <a:xfrm rot="20962444">
                <a:off x="438078" y="5300867"/>
                <a:ext cx="1581086" cy="685800"/>
              </a:xfrm>
              <a:prstGeom prst="ellipse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574995" y="5029200"/>
                <a:ext cx="8467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 err="1" smtClean="0">
                    <a:solidFill>
                      <a:srgbClr val="FF0000"/>
                    </a:solidFill>
                  </a:rPr>
                  <a:t>Kozak</a:t>
                </a:r>
                <a:r>
                  <a:rPr lang="en-US" sz="1050" dirty="0" smtClean="0">
                    <a:solidFill>
                      <a:srgbClr val="FF0000"/>
                    </a:solidFill>
                  </a:rPr>
                  <a:t>-stem</a:t>
                </a:r>
                <a:endParaRPr lang="en-US" sz="105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4724400" y="4191000"/>
                <a:ext cx="60960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878304" y="1820000"/>
              <a:ext cx="7156048" cy="1380400"/>
              <a:chOff x="878304" y="1820000"/>
              <a:chExt cx="7156048" cy="1380400"/>
            </a:xfrm>
          </p:grpSpPr>
          <p:sp>
            <p:nvSpPr>
              <p:cNvPr id="17" name="Oval 16"/>
              <p:cNvSpPr/>
              <p:nvPr/>
            </p:nvSpPr>
            <p:spPr>
              <a:xfrm rot="2457300">
                <a:off x="1716919" y="1820000"/>
                <a:ext cx="502887" cy="1043872"/>
              </a:xfrm>
              <a:prstGeom prst="ellipse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914400" y="2176790"/>
                <a:ext cx="78418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 smtClean="0">
                    <a:solidFill>
                      <a:srgbClr val="FF0000"/>
                    </a:solidFill>
                  </a:rPr>
                  <a:t>Basal helix</a:t>
                </a:r>
                <a:endParaRPr lang="en-US" sz="105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9" name="Oval 18"/>
              <p:cNvSpPr/>
              <p:nvPr/>
            </p:nvSpPr>
            <p:spPr>
              <a:xfrm rot="3475389">
                <a:off x="6870447" y="1960367"/>
                <a:ext cx="502887" cy="1043872"/>
              </a:xfrm>
              <a:prstGeom prst="ellipse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6096000" y="2133599"/>
                <a:ext cx="78418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 smtClean="0">
                    <a:solidFill>
                      <a:srgbClr val="FF0000"/>
                    </a:solidFill>
                  </a:rPr>
                  <a:t>Basal helix</a:t>
                </a:r>
                <a:endParaRPr lang="en-US" sz="105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878304" y="2514600"/>
                <a:ext cx="518091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i="1" dirty="0" smtClean="0">
                    <a:solidFill>
                      <a:srgbClr val="FF0000"/>
                    </a:solidFill>
                  </a:rPr>
                  <a:t>sORF1</a:t>
                </a:r>
                <a:endParaRPr lang="en-US" sz="1000" i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910781" y="2574760"/>
                <a:ext cx="518091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i="1" dirty="0" smtClean="0">
                    <a:solidFill>
                      <a:srgbClr val="FF0000"/>
                    </a:solidFill>
                  </a:rPr>
                  <a:t>sORF1</a:t>
                </a:r>
                <a:endParaRPr lang="en-US" sz="1000" i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7158792" y="2831068"/>
                <a:ext cx="87556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 smtClean="0">
                    <a:solidFill>
                      <a:srgbClr val="FF0000"/>
                    </a:solidFill>
                  </a:rPr>
                  <a:t>Shunt landing </a:t>
                </a:r>
              </a:p>
              <a:p>
                <a:pPr algn="ctr"/>
                <a:r>
                  <a:rPr lang="en-US" sz="900" b="1" dirty="0" smtClean="0">
                    <a:solidFill>
                      <a:srgbClr val="FF0000"/>
                    </a:solidFill>
                  </a:rPr>
                  <a:t>site</a:t>
                </a:r>
                <a:endParaRPr lang="en-US" sz="9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876928" y="2747208"/>
                <a:ext cx="87556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 smtClean="0">
                    <a:solidFill>
                      <a:srgbClr val="FF0000"/>
                    </a:solidFill>
                  </a:rPr>
                  <a:t>Shunt landing </a:t>
                </a:r>
              </a:p>
              <a:p>
                <a:pPr algn="ctr"/>
                <a:r>
                  <a:rPr lang="en-US" sz="900" b="1" dirty="0" smtClean="0">
                    <a:solidFill>
                      <a:srgbClr val="FF0000"/>
                    </a:solidFill>
                  </a:rPr>
                  <a:t>site</a:t>
                </a:r>
                <a:endParaRPr lang="en-US" sz="900" b="1" dirty="0">
                  <a:solidFill>
                    <a:srgbClr val="FF0000"/>
                  </a:solidFill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</TotalTime>
  <Words>230</Words>
  <Application>Microsoft Office PowerPoint</Application>
  <PresentationFormat>A4 Paper (210x297 mm)</PresentationFormat>
  <Paragraphs>9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ster</dc:creator>
  <cp:lastModifiedBy>master</cp:lastModifiedBy>
  <cp:revision>35</cp:revision>
  <dcterms:created xsi:type="dcterms:W3CDTF">2011-08-22T13:19:18Z</dcterms:created>
  <dcterms:modified xsi:type="dcterms:W3CDTF">2012-01-27T10:37:48Z</dcterms:modified>
</cp:coreProperties>
</file>